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66"/>
    <p:restoredTop sz="82843"/>
  </p:normalViewPr>
  <p:slideViewPr>
    <p:cSldViewPr snapToGrid="0">
      <p:cViewPr>
        <p:scale>
          <a:sx n="377" d="100"/>
          <a:sy n="377" d="100"/>
        </p:scale>
        <p:origin x="144" y="-8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1999A2-EA31-F14E-9C60-E03B2BC09FC2}" type="datetimeFigureOut">
              <a:rPr lang="en-US" smtClean="0"/>
              <a:t>8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1984B5-1C23-2640-A091-0EC43DF33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388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1984B5-1C23-2640-A091-0EC43DF33D3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0977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69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487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203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699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63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242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86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565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445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685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639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2DB45B-A38D-3C45-A27E-3CC9476BEF73}" type="datetimeFigureOut">
              <a:rPr lang="en-US" smtClean="0"/>
              <a:t>8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AA7534-7B41-5E4B-8A0C-06E310CFF2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129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38B3D5DA-DBFA-FE73-4A49-CB2E506C377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5641" b="6847"/>
          <a:stretch>
            <a:fillRect/>
          </a:stretch>
        </p:blipFill>
        <p:spPr>
          <a:xfrm>
            <a:off x="47594" y="1949521"/>
            <a:ext cx="2708237" cy="209919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0281D6E-CC5A-590E-4235-3AB7C51241B4}"/>
              </a:ext>
            </a:extLst>
          </p:cNvPr>
          <p:cNvSpPr txBox="1"/>
          <p:nvPr/>
        </p:nvSpPr>
        <p:spPr>
          <a:xfrm>
            <a:off x="139282" y="134532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3EFCC7-49EC-C82D-B189-DA9D79409E22}"/>
              </a:ext>
            </a:extLst>
          </p:cNvPr>
          <p:cNvSpPr txBox="1"/>
          <p:nvPr/>
        </p:nvSpPr>
        <p:spPr>
          <a:xfrm>
            <a:off x="3417780" y="134532"/>
            <a:ext cx="30649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350" b="1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D71F27-A3FE-EE54-70B4-F1184F4A2BBE}"/>
              </a:ext>
            </a:extLst>
          </p:cNvPr>
          <p:cNvSpPr txBox="1"/>
          <p:nvPr/>
        </p:nvSpPr>
        <p:spPr>
          <a:xfrm>
            <a:off x="146496" y="2222177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F07524D-4043-B184-3052-E4578CC6234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2166"/>
          <a:stretch>
            <a:fillRect/>
          </a:stretch>
        </p:blipFill>
        <p:spPr>
          <a:xfrm>
            <a:off x="2854733" y="434614"/>
            <a:ext cx="3955671" cy="279211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EFC5240-88DE-9C9B-095B-D17CEBD096EB}"/>
              </a:ext>
            </a:extLst>
          </p:cNvPr>
          <p:cNvSpPr txBox="1"/>
          <p:nvPr/>
        </p:nvSpPr>
        <p:spPr>
          <a:xfrm>
            <a:off x="96167" y="4124606"/>
            <a:ext cx="614900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fferential expression analysis reveals no increase in interferon signaling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in brain-resident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 Cells in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Alzheimer’s disease prefrontal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ortex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-B) Volcano plots of differentially expressed genes comparing AD cases and controls. (A) is using single-cell level while (B) is done with pseudo-bulking. (C) Functional enrichment analysis of the genes altered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 &lt; 0.05) in single-cell level analysis. Results show ubiquitin-binding function alteration. Overlapping hits from single-cell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seudobul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ethods are highlighted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4809599-C7F7-635A-A0B1-D3884B9D61EB}"/>
              </a:ext>
            </a:extLst>
          </p:cNvPr>
          <p:cNvSpPr/>
          <p:nvPr/>
        </p:nvSpPr>
        <p:spPr>
          <a:xfrm>
            <a:off x="2981038" y="491005"/>
            <a:ext cx="781333" cy="261697"/>
          </a:xfrm>
          <a:prstGeom prst="rect">
            <a:avLst/>
          </a:prstGeom>
          <a:noFill/>
          <a:ln w="952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72BE243-C930-675E-80B7-C9CA9590406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15360" r="6043" b="7676"/>
          <a:stretch>
            <a:fillRect/>
          </a:stretch>
        </p:blipFill>
        <p:spPr>
          <a:xfrm>
            <a:off x="47595" y="461340"/>
            <a:ext cx="2807137" cy="172458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A266539-581F-DE9A-66A1-C49DBEB727E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827" t="45233" r="92172" b="37574"/>
          <a:stretch>
            <a:fillRect/>
          </a:stretch>
        </p:blipFill>
        <p:spPr>
          <a:xfrm>
            <a:off x="96167" y="1099669"/>
            <a:ext cx="162523" cy="46563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C0822CA-7054-6E0B-6AD0-69F55F2E7BC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9960" t="85667" r="24034" b="8602"/>
          <a:stretch>
            <a:fillRect/>
          </a:stretch>
        </p:blipFill>
        <p:spPr>
          <a:xfrm>
            <a:off x="1293128" y="2048837"/>
            <a:ext cx="975136" cy="155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4970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28</TotalTime>
  <Words>88</Words>
  <Application>Microsoft Macintosh PowerPoint</Application>
  <PresentationFormat>Letter Paper (8.5x11 in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xendine, Jake</dc:creator>
  <cp:lastModifiedBy>Oxendine, Jake</cp:lastModifiedBy>
  <cp:revision>32</cp:revision>
  <dcterms:created xsi:type="dcterms:W3CDTF">2025-07-10T16:12:57Z</dcterms:created>
  <dcterms:modified xsi:type="dcterms:W3CDTF">2025-08-08T00:13:38Z</dcterms:modified>
</cp:coreProperties>
</file>